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65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0F3-417C-4951-B5FD-7A253851CB83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1BF35-9326-4412-A405-DAB4593D7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808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0F3-417C-4951-B5FD-7A253851CB83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1BF35-9326-4412-A405-DAB4593D7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900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0F3-417C-4951-B5FD-7A253851CB83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1BF35-9326-4412-A405-DAB4593D7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846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0F3-417C-4951-B5FD-7A253851CB83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1BF35-9326-4412-A405-DAB4593D7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59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0F3-417C-4951-B5FD-7A253851CB83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1BF35-9326-4412-A405-DAB4593D7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6427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0F3-417C-4951-B5FD-7A253851CB83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1BF35-9326-4412-A405-DAB4593D7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060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0F3-417C-4951-B5FD-7A253851CB83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1BF35-9326-4412-A405-DAB4593D7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352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0F3-417C-4951-B5FD-7A253851CB83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1BF35-9326-4412-A405-DAB4593D7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118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0F3-417C-4951-B5FD-7A253851CB83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1BF35-9326-4412-A405-DAB4593D7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593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0F3-417C-4951-B5FD-7A253851CB83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1BF35-9326-4412-A405-DAB4593D7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180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0F3-417C-4951-B5FD-7A253851CB83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91BF35-9326-4412-A405-DAB4593D7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459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060F3-417C-4951-B5FD-7A253851CB83}" type="datetimeFigureOut">
              <a:rPr lang="en-US" smtClean="0"/>
              <a:t>1/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91BF35-9326-4412-A405-DAB4593D70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053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6" Type="http://schemas.openxmlformats.org/officeDocument/2006/relationships/image" Target="../media/image4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625283"/>
            <a:ext cx="10134600" cy="2616836"/>
          </a:xfrm>
        </p:spPr>
        <p:txBody>
          <a:bodyPr>
            <a:normAutofit/>
          </a:bodyPr>
          <a:lstStyle/>
          <a:p>
            <a:r>
              <a:rPr lang="en-US" sz="4000" b="1" dirty="0"/>
              <a:t>Supplementary Materials: Super-Efficient Synthesis of Mesh-like </a:t>
            </a:r>
            <a:r>
              <a:rPr lang="en-US" sz="4000" b="1" dirty="0" err="1"/>
              <a:t>Superhydrophobic</a:t>
            </a:r>
            <a:r>
              <a:rPr lang="en-US" sz="4000" b="1" dirty="0"/>
              <a:t> Nano-Aluminum/Iron (III) Oxide Energetic Films</a:t>
            </a:r>
            <a:r>
              <a:rPr lang="en-US" dirty="0"/>
              <a:t/>
            </a:r>
            <a:br>
              <a:rPr lang="en-US" dirty="0"/>
            </a:b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242118"/>
            <a:ext cx="9631680" cy="809942"/>
          </a:xfrm>
        </p:spPr>
        <p:txBody>
          <a:bodyPr>
            <a:normAutofit/>
          </a:bodyPr>
          <a:lstStyle/>
          <a:p>
            <a:r>
              <a:rPr lang="de-DE" b="1" dirty="0"/>
              <a:t>Xiaogang Guo and Taotao Liang</a:t>
            </a:r>
            <a:r>
              <a:rPr lang="en-US" b="1" dirty="0"/>
              <a:t/>
            </a:r>
            <a:br>
              <a:rPr lang="en-US" b="1" dirty="0"/>
            </a:br>
            <a:endParaRPr lang="en-US" dirty="0"/>
          </a:p>
        </p:txBody>
      </p:sp>
      <p:pic>
        <p:nvPicPr>
          <p:cNvPr id="4" name="Picture 3" descr="C:\Users\home\Desktop\logos\materials-logo .pn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443" y="287020"/>
            <a:ext cx="2111114" cy="5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C:\Users\home\Desktop\logos\ori\png\logo-mdpi.pn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45927" y="287020"/>
            <a:ext cx="844145" cy="5588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7045546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Users\home\Desktop\logos\materials-logo .pn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443" y="287020"/>
            <a:ext cx="2111114" cy="5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C:\Users\home\Desktop\logos\ori\png\logo-mdpi.pn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45927" y="287020"/>
            <a:ext cx="844145" cy="5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Video S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2482362" y="951181"/>
            <a:ext cx="6934200" cy="390525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161822" y="5334000"/>
            <a:ext cx="75407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Video SI.</a:t>
            </a:r>
            <a:r>
              <a:rPr lang="en-GB" dirty="0"/>
              <a:t> The droplet impacting process of the SAFFs, using red ink-dyed </a:t>
            </a:r>
            <a:r>
              <a:rPr lang="en-GB" dirty="0" smtClean="0"/>
              <a:t>water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252654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Users\home\Desktop\logos\materials-logo .pn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443" y="287020"/>
            <a:ext cx="2111114" cy="558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C:\Users\home\Desktop\logos\ori\png\logo-mdpi.pn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45927" y="287020"/>
            <a:ext cx="844145" cy="558800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TextBox 8"/>
          <p:cNvSpPr txBox="1"/>
          <p:nvPr/>
        </p:nvSpPr>
        <p:spPr>
          <a:xfrm>
            <a:off x="1524000" y="5833475"/>
            <a:ext cx="849923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Video </a:t>
            </a:r>
            <a:r>
              <a:rPr lang="en-GB" b="1" dirty="0" smtClean="0"/>
              <a:t>S2.</a:t>
            </a:r>
            <a:r>
              <a:rPr lang="en-GB" dirty="0" smtClean="0"/>
              <a:t> </a:t>
            </a:r>
            <a:r>
              <a:rPr lang="en-GB" dirty="0"/>
              <a:t>The droplet impacting test of SAFFs fixed at a certain angle. The water droplets were sprayed on the surface and bounced-off quickly, suggesting the outstanding </a:t>
            </a:r>
            <a:r>
              <a:rPr lang="en-GB" dirty="0" err="1"/>
              <a:t>superhydrophobicity</a:t>
            </a:r>
            <a:r>
              <a:rPr lang="en-GB" dirty="0"/>
              <a:t> of the SAFFs.</a:t>
            </a:r>
            <a:endParaRPr lang="en-US" dirty="0"/>
          </a:p>
        </p:txBody>
      </p:sp>
      <p:pic>
        <p:nvPicPr>
          <p:cNvPr id="2" name="Video SII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 rot="5400000">
            <a:off x="2746979" y="1755451"/>
            <a:ext cx="5217577" cy="29384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935783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5</TotalTime>
  <Words>71</Words>
  <Application>Microsoft Office PowerPoint</Application>
  <PresentationFormat>Widescreen</PresentationFormat>
  <Paragraphs>4</Paragraphs>
  <Slides>3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Supplementary Materials: Super-Efficient Synthesis of Mesh-like Superhydrophobic Nano-Aluminum/Iron (III) Oxide Energetic Films 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DPI</dc:creator>
  <cp:lastModifiedBy>MDPI</cp:lastModifiedBy>
  <cp:revision>18</cp:revision>
  <dcterms:created xsi:type="dcterms:W3CDTF">2018-12-04T05:34:45Z</dcterms:created>
  <dcterms:modified xsi:type="dcterms:W3CDTF">2019-01-04T01:38:15Z</dcterms:modified>
</cp:coreProperties>
</file>